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2" d="100"/>
          <a:sy n="122" d="100"/>
        </p:scale>
        <p:origin x="120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E3534C-1FFE-4015-87EF-D82D2FA4FF6A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29B14-316E-41A7-A00F-605C9985F2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311958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E3534C-1FFE-4015-87EF-D82D2FA4FF6A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29B14-316E-41A7-A00F-605C9985F2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35476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E3534C-1FFE-4015-87EF-D82D2FA4FF6A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29B14-316E-41A7-A00F-605C9985F2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954716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E3534C-1FFE-4015-87EF-D82D2FA4FF6A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29B14-316E-41A7-A00F-605C9985F2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207468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E3534C-1FFE-4015-87EF-D82D2FA4FF6A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29B14-316E-41A7-A00F-605C9985F2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516059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E3534C-1FFE-4015-87EF-D82D2FA4FF6A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29B14-316E-41A7-A00F-605C9985F2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274733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E3534C-1FFE-4015-87EF-D82D2FA4FF6A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29B14-316E-41A7-A00F-605C9985F2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733783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E3534C-1FFE-4015-87EF-D82D2FA4FF6A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29B14-316E-41A7-A00F-605C9985F2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161489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E3534C-1FFE-4015-87EF-D82D2FA4FF6A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29B14-316E-41A7-A00F-605C9985F2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16046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E3534C-1FFE-4015-87EF-D82D2FA4FF6A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29B14-316E-41A7-A00F-605C9985F2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97690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E3534C-1FFE-4015-87EF-D82D2FA4FF6A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29B14-316E-41A7-A00F-605C9985F2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087985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E3534C-1FFE-4015-87EF-D82D2FA4FF6A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A29B14-316E-41A7-A00F-605C9985F2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076481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51641888"/>
              </p:ext>
            </p:extLst>
          </p:nvPr>
        </p:nvGraphicFramePr>
        <p:xfrm>
          <a:off x="2648438" y="1428140"/>
          <a:ext cx="3783013" cy="2452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Prism 8" r:id="rId3" imgW="3782505" imgH="2453009" progId="Prism8.Document">
                  <p:embed/>
                </p:oleObj>
              </mc:Choice>
              <mc:Fallback>
                <p:oleObj name="Prism 8" r:id="rId3" imgW="3782505" imgH="2453009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648438" y="1428140"/>
                        <a:ext cx="3783013" cy="2452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feld 2"/>
          <p:cNvSpPr txBox="1"/>
          <p:nvPr/>
        </p:nvSpPr>
        <p:spPr>
          <a:xfrm>
            <a:off x="7499" y="7499"/>
            <a:ext cx="2749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2756970" y="4306277"/>
            <a:ext cx="33233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hown are the leukocyte numbers immediate before delivery </a:t>
            </a:r>
            <a:r>
              <a:rPr lang="en-GB" sz="120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GB" sz="1200" smtClean="0">
                <a:latin typeface="Arial" panose="020B0604020202020204" pitchFamily="34" charset="0"/>
                <a:cs typeface="Arial" panose="020B0604020202020204" pitchFamily="34" charset="0"/>
              </a:rPr>
              <a:t>TD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nd PTB patients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73937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</Words>
  <Application>Microsoft Office PowerPoint</Application>
  <PresentationFormat>Breitbild</PresentationFormat>
  <Paragraphs>3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Prism 8</vt:lpstr>
      <vt:lpstr>PowerPoint-Präsentation</vt:lpstr>
    </vt:vector>
  </TitlesOfParts>
  <Company>UMM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usse, Mandy</dc:creator>
  <cp:lastModifiedBy>Busse, Mandy</cp:lastModifiedBy>
  <cp:revision>4</cp:revision>
  <dcterms:created xsi:type="dcterms:W3CDTF">2019-12-18T11:14:40Z</dcterms:created>
  <dcterms:modified xsi:type="dcterms:W3CDTF">2020-02-07T12:35:27Z</dcterms:modified>
</cp:coreProperties>
</file>